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0" autoAdjust="0"/>
    <p:restoredTop sz="94660"/>
  </p:normalViewPr>
  <p:slideViewPr>
    <p:cSldViewPr snapToGrid="0">
      <p:cViewPr varScale="1">
        <p:scale>
          <a:sx n="61" d="100"/>
          <a:sy n="61" d="100"/>
        </p:scale>
        <p:origin x="62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C44D3-3336-43A5-A007-2E739B7DF3F5}" type="datetimeFigureOut">
              <a:rPr lang="fr-FR" smtClean="0"/>
              <a:t>29/1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C23C8-2A79-4AD9-A275-1B083999B76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753245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C44D3-3336-43A5-A007-2E739B7DF3F5}" type="datetimeFigureOut">
              <a:rPr lang="fr-FR" smtClean="0"/>
              <a:t>29/1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C23C8-2A79-4AD9-A275-1B083999B76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54245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C44D3-3336-43A5-A007-2E739B7DF3F5}" type="datetimeFigureOut">
              <a:rPr lang="fr-FR" smtClean="0"/>
              <a:t>29/1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C23C8-2A79-4AD9-A275-1B083999B76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16955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C44D3-3336-43A5-A007-2E739B7DF3F5}" type="datetimeFigureOut">
              <a:rPr lang="fr-FR" smtClean="0"/>
              <a:t>29/1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C23C8-2A79-4AD9-A275-1B083999B76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4873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C44D3-3336-43A5-A007-2E739B7DF3F5}" type="datetimeFigureOut">
              <a:rPr lang="fr-FR" smtClean="0"/>
              <a:t>29/1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C23C8-2A79-4AD9-A275-1B083999B76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442257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C44D3-3336-43A5-A007-2E739B7DF3F5}" type="datetimeFigureOut">
              <a:rPr lang="fr-FR" smtClean="0"/>
              <a:t>29/11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C23C8-2A79-4AD9-A275-1B083999B76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402051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C44D3-3336-43A5-A007-2E739B7DF3F5}" type="datetimeFigureOut">
              <a:rPr lang="fr-FR" smtClean="0"/>
              <a:t>29/11/202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C23C8-2A79-4AD9-A275-1B083999B76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825379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C44D3-3336-43A5-A007-2E739B7DF3F5}" type="datetimeFigureOut">
              <a:rPr lang="fr-FR" smtClean="0"/>
              <a:t>29/11/202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C23C8-2A79-4AD9-A275-1B083999B76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125730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C44D3-3336-43A5-A007-2E739B7DF3F5}" type="datetimeFigureOut">
              <a:rPr lang="fr-FR" smtClean="0"/>
              <a:t>29/11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C23C8-2A79-4AD9-A275-1B083999B76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601146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C44D3-3336-43A5-A007-2E739B7DF3F5}" type="datetimeFigureOut">
              <a:rPr lang="fr-FR" smtClean="0"/>
              <a:t>29/11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C23C8-2A79-4AD9-A275-1B083999B76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412898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C44D3-3336-43A5-A007-2E739B7DF3F5}" type="datetimeFigureOut">
              <a:rPr lang="fr-FR" smtClean="0"/>
              <a:t>29/11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C23C8-2A79-4AD9-A275-1B083999B76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325581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DC44D3-3336-43A5-A007-2E739B7DF3F5}" type="datetimeFigureOut">
              <a:rPr lang="fr-FR" smtClean="0"/>
              <a:t>29/1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2C23C8-2A79-4AD9-A275-1B083999B76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79014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85951" y="497382"/>
            <a:ext cx="10515600" cy="1325563"/>
          </a:xfrm>
        </p:spPr>
        <p:txBody>
          <a:bodyPr>
            <a:normAutofit/>
          </a:bodyPr>
          <a:lstStyle/>
          <a:p>
            <a:r>
              <a:rPr lang="fr-FR" sz="4000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</a:t>
            </a:r>
            <a:r>
              <a:rPr lang="fr-FR" sz="4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able 1: </a:t>
            </a:r>
            <a:r>
              <a:rPr lang="fr-FR" sz="4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lobal </a:t>
            </a:r>
            <a:r>
              <a:rPr lang="fr-FR" sz="4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ran’I</a:t>
            </a:r>
            <a:r>
              <a:rPr lang="fr-FR" sz="4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4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atistics</a:t>
            </a:r>
            <a:r>
              <a:rPr lang="fr-FR" sz="4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fr-FR" sz="4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oodness</a:t>
            </a:r>
            <a:r>
              <a:rPr lang="fr-FR" sz="4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f </a:t>
            </a:r>
            <a:r>
              <a:rPr lang="fr-FR" sz="4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ts</a:t>
            </a:r>
            <a:r>
              <a:rPr lang="fr-FR" sz="4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 </a:t>
            </a:r>
          </a:p>
        </p:txBody>
      </p:sp>
      <p:graphicFrame>
        <p:nvGraphicFramePr>
          <p:cNvPr id="6" name="Espace réservé du contenu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689468493"/>
              </p:ext>
            </p:extLst>
          </p:nvPr>
        </p:nvGraphicFramePr>
        <p:xfrm>
          <a:off x="2557955" y="2422655"/>
          <a:ext cx="6571593" cy="267120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220310">
                  <a:extLst>
                    <a:ext uri="{9D8B030D-6E8A-4147-A177-3AD203B41FA5}">
                      <a16:colId xmlns:a16="http://schemas.microsoft.com/office/drawing/2014/main" val="343182385"/>
                    </a:ext>
                  </a:extLst>
                </a:gridCol>
                <a:gridCol w="1481959">
                  <a:extLst>
                    <a:ext uri="{9D8B030D-6E8A-4147-A177-3AD203B41FA5}">
                      <a16:colId xmlns:a16="http://schemas.microsoft.com/office/drawing/2014/main" val="3890927478"/>
                    </a:ext>
                  </a:extLst>
                </a:gridCol>
                <a:gridCol w="1324303">
                  <a:extLst>
                    <a:ext uri="{9D8B030D-6E8A-4147-A177-3AD203B41FA5}">
                      <a16:colId xmlns:a16="http://schemas.microsoft.com/office/drawing/2014/main" val="1533295771"/>
                    </a:ext>
                  </a:extLst>
                </a:gridCol>
                <a:gridCol w="1545021">
                  <a:extLst>
                    <a:ext uri="{9D8B030D-6E8A-4147-A177-3AD203B41FA5}">
                      <a16:colId xmlns:a16="http://schemas.microsoft.com/office/drawing/2014/main" val="696926528"/>
                    </a:ext>
                  </a:extLst>
                </a:gridCol>
              </a:tblGrid>
              <a:tr h="1051559"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dirty="0" smtClean="0"/>
                        <a:t>OLS1</a:t>
                      </a:r>
                    </a:p>
                    <a:p>
                      <a:pPr algn="ctr"/>
                      <a:r>
                        <a:rPr lang="fr-FR" dirty="0" smtClean="0"/>
                        <a:t>Non- spatial SLM1 </a:t>
                      </a:r>
                      <a:endParaRPr lang="fr-FR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dirty="0" smtClean="0"/>
                        <a:t>OLS2 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dirty="0" smtClean="0"/>
                        <a:t>Non- spatial SLM2</a:t>
                      </a:r>
                    </a:p>
                    <a:p>
                      <a:pPr algn="ctr"/>
                      <a:endParaRPr lang="fr-FR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dirty="0" smtClean="0"/>
                        <a:t>OLS3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dirty="0" smtClean="0"/>
                        <a:t>Non- spatial SLM3 </a:t>
                      </a:r>
                    </a:p>
                    <a:p>
                      <a:pPr algn="ctr"/>
                      <a:endParaRPr lang="fr-FR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2365875"/>
                  </a:ext>
                </a:extLst>
              </a:tr>
              <a:tr h="348895">
                <a:tc>
                  <a:txBody>
                    <a:bodyPr/>
                    <a:lstStyle/>
                    <a:p>
                      <a:r>
                        <a:rPr lang="fr-FR" dirty="0" smtClean="0"/>
                        <a:t>AIC</a:t>
                      </a:r>
                      <a:endParaRPr lang="fr-FR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dirty="0" smtClean="0"/>
                        <a:t>3184</a:t>
                      </a:r>
                      <a:endParaRPr lang="fr-FR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dirty="0" smtClean="0"/>
                        <a:t>3133</a:t>
                      </a:r>
                      <a:endParaRPr lang="fr-FR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dirty="0" smtClean="0"/>
                        <a:t>3136</a:t>
                      </a:r>
                      <a:endParaRPr lang="fr-FR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747418341"/>
                  </a:ext>
                </a:extLst>
              </a:tr>
              <a:tr h="60220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dirty="0" err="1" smtClean="0"/>
                        <a:t>Moran’s</a:t>
                      </a:r>
                      <a:r>
                        <a:rPr lang="fr-FR" dirty="0" smtClean="0"/>
                        <a:t> I on </a:t>
                      </a:r>
                      <a:r>
                        <a:rPr lang="fr-FR" dirty="0" err="1" smtClean="0"/>
                        <a:t>residuals</a:t>
                      </a:r>
                      <a:r>
                        <a:rPr lang="fr-FR" dirty="0" smtClean="0"/>
                        <a:t> </a:t>
                      </a:r>
                    </a:p>
                    <a:p>
                      <a:r>
                        <a:rPr lang="fr-FR" dirty="0" smtClean="0"/>
                        <a:t>&amp; P value </a:t>
                      </a:r>
                      <a:endParaRPr lang="fr-FR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dirty="0" smtClean="0"/>
                        <a:t>0.16</a:t>
                      </a:r>
                    </a:p>
                    <a:p>
                      <a:pPr algn="ctr"/>
                      <a:r>
                        <a:rPr lang="fr-FR" dirty="0" smtClean="0"/>
                        <a:t>P&lt;0.01</a:t>
                      </a:r>
                      <a:endParaRPr lang="fr-FR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dirty="0" smtClean="0"/>
                        <a:t>0.12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dirty="0" smtClean="0"/>
                        <a:t>P&lt;0.0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dirty="0" smtClean="0"/>
                        <a:t>0.13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dirty="0" smtClean="0"/>
                        <a:t>P&lt;0.0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25109302"/>
                  </a:ext>
                </a:extLst>
              </a:tr>
              <a:tr h="476644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dirty="0" smtClean="0"/>
                        <a:t>R²</a:t>
                      </a:r>
                      <a:r>
                        <a:rPr lang="fr-FR" baseline="0" dirty="0" smtClean="0"/>
                        <a:t> </a:t>
                      </a:r>
                      <a:r>
                        <a:rPr lang="fr-FR" baseline="0" dirty="0" err="1" smtClean="0"/>
                        <a:t>adjusted</a:t>
                      </a:r>
                      <a:r>
                        <a:rPr lang="fr-FR" baseline="0" dirty="0" smtClean="0"/>
                        <a:t> </a:t>
                      </a:r>
                      <a:endParaRPr lang="fr-FR" dirty="0" smtClean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dirty="0" smtClean="0"/>
                        <a:t>0.34</a:t>
                      </a:r>
                      <a:endParaRPr lang="fr-FR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dirty="0" smtClean="0"/>
                        <a:t>0.40</a:t>
                      </a:r>
                      <a:endParaRPr lang="fr-FR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dirty="0" smtClean="0"/>
                        <a:t>0.40</a:t>
                      </a:r>
                      <a:endParaRPr lang="fr-FR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18510826"/>
                  </a:ext>
                </a:extLst>
              </a:tr>
            </a:tbl>
          </a:graphicData>
        </a:graphic>
      </p:graphicFrame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B7FD5E6-DE88-CB49-8F7D-2CE36B949C49}" type="slidenum">
              <a:rPr lang="fr-FR" altLang="fr-FR" smtClean="0"/>
              <a:pPr/>
              <a:t>1</a:t>
            </a:fld>
            <a:endParaRPr lang="fr-FR" altLang="fr-FR" sz="1400">
              <a:latin typeface="Times" pitchFamily="2" charset="0"/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r>
              <a:rPr lang="fr-FR"/>
              <a:t>EHESP</a:t>
            </a:r>
            <a:endParaRPr lang="fr-FR" sz="1000"/>
          </a:p>
        </p:txBody>
      </p:sp>
    </p:spTree>
    <p:extLst>
      <p:ext uri="{BB962C8B-B14F-4D97-AF65-F5344CB8AC3E}">
        <p14:creationId xmlns:p14="http://schemas.microsoft.com/office/powerpoint/2010/main" val="40309784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</TotalTime>
  <Words>47</Words>
  <Application>Microsoft Office PowerPoint</Application>
  <PresentationFormat>Grand écran</PresentationFormat>
  <Paragraphs>2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</vt:lpstr>
      <vt:lpstr>Times New Roman</vt:lpstr>
      <vt:lpstr>Thème Office</vt:lpstr>
      <vt:lpstr>Supplementary table 1: Global Moran’I statistics and goodness of fits  </vt:lpstr>
    </vt:vector>
  </TitlesOfParts>
  <Company>EHES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dditional table 1: Global Moran’I statistics and goodness of fits  </dc:title>
  <dc:creator>Padilla, Cindy</dc:creator>
  <cp:lastModifiedBy>Padilla, Cindy</cp:lastModifiedBy>
  <cp:revision>4</cp:revision>
  <dcterms:created xsi:type="dcterms:W3CDTF">2022-11-18T13:49:41Z</dcterms:created>
  <dcterms:modified xsi:type="dcterms:W3CDTF">2022-11-29T13:46:57Z</dcterms:modified>
</cp:coreProperties>
</file>